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0" d="100"/>
          <a:sy n="150" d="100"/>
        </p:scale>
        <p:origin x="2016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99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620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622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734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451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036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814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801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565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585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3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F5B15-AD66-4290-A8BB-4BF8CBE5C2C6}" type="datetimeFigureOut">
              <a:rPr lang="en-US" smtClean="0"/>
              <a:t>4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D4CD2-3E70-43EF-8C70-42A24C5260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38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864883" y="3697106"/>
            <a:ext cx="16588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ABBV-323 Fab alone</a:t>
            </a:r>
          </a:p>
          <a:p>
            <a:pPr algn="ctr"/>
            <a:r>
              <a:rPr lang="en-US" sz="1400" dirty="0"/>
              <a:t>Outliers: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76600" y="3697106"/>
            <a:ext cx="266771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ABBV-323 Fab complexed to CD40</a:t>
            </a:r>
          </a:p>
          <a:p>
            <a:pPr algn="ctr"/>
            <a:r>
              <a:rPr lang="en-US" sz="1400" dirty="0"/>
              <a:t>Outliers:</a:t>
            </a:r>
          </a:p>
        </p:txBody>
      </p:sp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5439919"/>
              </p:ext>
            </p:extLst>
          </p:nvPr>
        </p:nvGraphicFramePr>
        <p:xfrm>
          <a:off x="3429000" y="4281464"/>
          <a:ext cx="2362200" cy="8229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1811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11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h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Resid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1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1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28" name="Table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2892754"/>
              </p:ext>
            </p:extLst>
          </p:nvPr>
        </p:nvGraphicFramePr>
        <p:xfrm>
          <a:off x="513209" y="4281464"/>
          <a:ext cx="2362200" cy="5486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1811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11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h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Resid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1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29" name="Table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3628949"/>
              </p:ext>
            </p:extLst>
          </p:nvPr>
        </p:nvGraphicFramePr>
        <p:xfrm>
          <a:off x="6267450" y="4281464"/>
          <a:ext cx="2628900" cy="11582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3144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4061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h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Resid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aseline="0" dirty="0"/>
                        <a:t>V153, P152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1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U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6477000" y="3697106"/>
            <a:ext cx="21885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FAB516 complexed to CD40</a:t>
            </a:r>
          </a:p>
          <a:p>
            <a:pPr algn="ctr"/>
            <a:r>
              <a:rPr lang="en-US" sz="1400" dirty="0"/>
              <a:t>Outliers: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05339" y="150109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304801" y="152290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248400" y="150109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8865151-1CB8-4319-A683-EDC20334855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0850" y="1630836"/>
            <a:ext cx="2012146" cy="19873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7340E8A-16CF-4A8A-8415-CA242FF8760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1295" y="1630836"/>
            <a:ext cx="2027505" cy="19873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A814BE7-2282-48EE-8BD6-4D16AD222EC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1626493"/>
            <a:ext cx="2090740" cy="20094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831364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8</TotalTime>
  <Words>41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bbVie In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Rui</dc:creator>
  <cp:lastModifiedBy>Argiriadi, Maria A</cp:lastModifiedBy>
  <cp:revision>22</cp:revision>
  <dcterms:created xsi:type="dcterms:W3CDTF">2018-12-11T15:35:32Z</dcterms:created>
  <dcterms:modified xsi:type="dcterms:W3CDTF">2019-04-11T21:26:04Z</dcterms:modified>
</cp:coreProperties>
</file>